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2A1373-83CC-4443-9CEA-E03640857AD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BC58E9-D4F8-40DD-B0BE-A2D855955C2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8BDE37-D899-465A-88B7-9200938BF17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8F7C33-A1F2-4261-BEA3-A1B5E26B81E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59C957-031D-4FF8-9876-A2737FE7A25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3CBC20-E40C-4AE3-A17C-14904DC2A7D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32F3AD-372E-45C1-8C01-2D1AB8EE1AD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5ACF9D-40CB-4B74-A3E8-710975990EA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CF8702-6A3A-43E3-8B2A-6119C2669C0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6B3816-E420-47B4-8595-770258B14A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1D05A9-47E9-4033-8C53-B97E63053C8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C7533F-C058-40C5-B06E-AC4546216A5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8BFC735-0443-4D84-805D-AC519C5F40B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727360" y="502920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5219640" y="3851280"/>
            <a:ext cx="1000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5219640" y="3770280"/>
            <a:ext cx="1000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3833640" y="4543560"/>
            <a:ext cx="1000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4311720" y="3751200"/>
            <a:ext cx="982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4518000" y="3805200"/>
            <a:ext cx="982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4518000" y="3976560"/>
            <a:ext cx="9828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3833640" y="4525920"/>
            <a:ext cx="10008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4311720" y="406728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5219640" y="4040280"/>
            <a:ext cx="1000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5219640" y="3949560"/>
            <a:ext cx="10008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3833640" y="4830840"/>
            <a:ext cx="1000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4311720" y="421956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4518000" y="404028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4518000" y="4138560"/>
            <a:ext cx="9828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3833640" y="4830840"/>
            <a:ext cx="1000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4311720" y="438156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2727360" y="479592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4203720" y="3328920"/>
            <a:ext cx="9828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6678720" y="2284560"/>
            <a:ext cx="98280" cy="997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120" bIns="24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3438360" y="4759200"/>
            <a:ext cx="9864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3438360" y="4813200"/>
            <a:ext cx="9864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4203720" y="318456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6678720" y="3112920"/>
            <a:ext cx="9828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4203720" y="2986200"/>
            <a:ext cx="982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6678720" y="172728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3438360" y="4633920"/>
            <a:ext cx="9864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3438360" y="4695840"/>
            <a:ext cx="9864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4203720" y="295128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6678720" y="281628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5408640" y="3454560"/>
            <a:ext cx="100080" cy="997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120" bIns="24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3492360" y="3255840"/>
            <a:ext cx="9864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3492360" y="3446640"/>
            <a:ext cx="9864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2727360" y="4705200"/>
            <a:ext cx="9828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5408640" y="3733920"/>
            <a:ext cx="1000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6012000" y="1573200"/>
            <a:ext cx="982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6012000" y="245592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5408640" y="3409920"/>
            <a:ext cx="1000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2727360" y="482292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2727360" y="4948200"/>
            <a:ext cx="9828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3492360" y="3121200"/>
            <a:ext cx="98640" cy="997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120" bIns="24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6012000" y="2959200"/>
            <a:ext cx="982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3492360" y="3427560"/>
            <a:ext cx="98640" cy="997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120" bIns="24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6012000" y="3328920"/>
            <a:ext cx="9828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5408640" y="3851280"/>
            <a:ext cx="1000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2771640" y="5218200"/>
            <a:ext cx="36896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2771640" y="5218200"/>
            <a:ext cx="1800" cy="81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3689280" y="5218200"/>
            <a:ext cx="1800" cy="81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4616280" y="5218200"/>
            <a:ext cx="1800" cy="81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5535720" y="5218200"/>
            <a:ext cx="1440" cy="81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6461280" y="5218200"/>
            <a:ext cx="1440" cy="81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2664000" y="5345280"/>
            <a:ext cx="12096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3465360" y="5345280"/>
            <a:ext cx="36180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500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4334040" y="5345280"/>
            <a:ext cx="48240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1000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5253120" y="5345280"/>
            <a:ext cx="48240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1500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6178680" y="5345280"/>
            <a:ext cx="48240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2000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 flipV="1">
            <a:off x="2610000" y="2257200"/>
            <a:ext cx="1440" cy="2447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 flipH="1">
            <a:off x="2528640" y="4705200"/>
            <a:ext cx="810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 flipH="1">
            <a:off x="2528640" y="3886200"/>
            <a:ext cx="810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 flipH="1">
            <a:off x="2528640" y="3076560"/>
            <a:ext cx="810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 flipH="1">
            <a:off x="2528640" y="2257560"/>
            <a:ext cx="810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 rot="16200000">
            <a:off x="2275920" y="4619160"/>
            <a:ext cx="12096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 rot="16200000">
            <a:off x="2275920" y="3803400"/>
            <a:ext cx="12096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 rot="16200000">
            <a:off x="2275920" y="2993760"/>
            <a:ext cx="12096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 rot="16200000">
            <a:off x="2275920" y="2171520"/>
            <a:ext cx="12096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2610000" y="1474920"/>
            <a:ext cx="4265640" cy="3743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4427280" y="1052640"/>
            <a:ext cx="60120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700" spc="-1" strike="noStrike">
                <a:solidFill>
                  <a:srgbClr val="000000"/>
                </a:solidFill>
                <a:latin typeface="Arial"/>
              </a:rPr>
              <a:t>Turtle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5961960" y="4862520"/>
            <a:ext cx="907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</a:t>
            </a:r>
            <a:r>
              <a:rPr b="0" lang="en-US" sz="18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=0.5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397080" y="333360"/>
            <a:ext cx="650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3a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3713040" y="5877000"/>
            <a:ext cx="2149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600" spc="-1" strike="noStrike">
                <a:solidFill>
                  <a:srgbClr val="000000"/>
                </a:solidFill>
                <a:latin typeface="Arial"/>
              </a:rPr>
              <a:t>geographic distanc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1118880" y="3135240"/>
            <a:ext cx="100224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600" spc="-1" strike="noStrike">
                <a:solidFill>
                  <a:srgbClr val="000000"/>
                </a:solidFill>
                <a:latin typeface="Arial"/>
              </a:rPr>
              <a:t>genetic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600" spc="-1" strike="noStrike">
                <a:solidFill>
                  <a:srgbClr val="000000"/>
                </a:solidFill>
                <a:latin typeface="Arial"/>
              </a:rPr>
              <a:t>distanc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"/>
          <p:cNvSpPr/>
          <p:nvPr/>
        </p:nvSpPr>
        <p:spPr>
          <a:xfrm>
            <a:off x="5947560" y="4862520"/>
            <a:ext cx="907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</a:t>
            </a:r>
            <a:r>
              <a:rPr b="0" lang="en-US" sz="18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=0.0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2763720" y="3625920"/>
            <a:ext cx="9864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4518000" y="2986200"/>
            <a:ext cx="982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4518000" y="2932200"/>
            <a:ext cx="982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4878360" y="2878200"/>
            <a:ext cx="982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4878360" y="2581200"/>
            <a:ext cx="982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5265720" y="2519280"/>
            <a:ext cx="9828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5265720" y="3500280"/>
            <a:ext cx="9828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5265720" y="3274920"/>
            <a:ext cx="9828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2727360" y="1573200"/>
            <a:ext cx="982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4491000" y="2374920"/>
            <a:ext cx="9864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4481640" y="2662200"/>
            <a:ext cx="9972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4851360" y="2924280"/>
            <a:ext cx="9864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4851360" y="2374920"/>
            <a:ext cx="9864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5229360" y="197964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5229360" y="315756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5256360" y="2446200"/>
            <a:ext cx="982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2727360" y="1663560"/>
            <a:ext cx="982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5021280" y="2392200"/>
            <a:ext cx="1000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5003640" y="3905280"/>
            <a:ext cx="9864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5003640" y="2212920"/>
            <a:ext cx="9864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4005360" y="3094200"/>
            <a:ext cx="98280" cy="997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120" bIns="24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4014720" y="5029200"/>
            <a:ext cx="9864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6669000" y="3040200"/>
            <a:ext cx="98640" cy="997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120" bIns="24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2727360" y="172728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3240000" y="2860560"/>
            <a:ext cx="9864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3240000" y="2077920"/>
            <a:ext cx="9864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4734000" y="2851200"/>
            <a:ext cx="982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4734000" y="3400560"/>
            <a:ext cx="98280" cy="997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120" bIns="24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4689360" y="2446200"/>
            <a:ext cx="9864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2727360" y="2284560"/>
            <a:ext cx="98280" cy="997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120" bIns="24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2727360" y="2878200"/>
            <a:ext cx="982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4427640" y="3166920"/>
            <a:ext cx="10008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4427640" y="4317840"/>
            <a:ext cx="1000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5121360" y="331956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2727360" y="230364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4427640" y="2311560"/>
            <a:ext cx="100080" cy="997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120" bIns="24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4427640" y="3184560"/>
            <a:ext cx="1000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5111640" y="2860560"/>
            <a:ext cx="9864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2727360" y="2077920"/>
            <a:ext cx="9828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2727360" y="3976560"/>
            <a:ext cx="9828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6678720" y="2338560"/>
            <a:ext cx="98280" cy="997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120" bIns="24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2727360" y="2077920"/>
            <a:ext cx="9828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6678720" y="3355920"/>
            <a:ext cx="9828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2727360" y="313056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2727360" y="2725560"/>
            <a:ext cx="9828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2771640" y="5218200"/>
            <a:ext cx="31593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2771640" y="5218200"/>
            <a:ext cx="1800" cy="81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3824280" y="5218200"/>
            <a:ext cx="1440" cy="81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4878360" y="5218200"/>
            <a:ext cx="1440" cy="81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5931000" y="5218200"/>
            <a:ext cx="1440" cy="81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2664000" y="5345280"/>
            <a:ext cx="12096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3600360" y="5345280"/>
            <a:ext cx="36180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200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4654440" y="5345280"/>
            <a:ext cx="36180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400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5707080" y="5345280"/>
            <a:ext cx="36180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600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 flipV="1">
            <a:off x="2610000" y="2104560"/>
            <a:ext cx="1440" cy="2590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 flipH="1">
            <a:off x="2528640" y="4695840"/>
            <a:ext cx="810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 flipH="1">
            <a:off x="2528640" y="4048200"/>
            <a:ext cx="810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 flipH="1">
            <a:off x="2528640" y="3400560"/>
            <a:ext cx="810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 flipH="1">
            <a:off x="2528640" y="2752560"/>
            <a:ext cx="810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 flipH="1">
            <a:off x="2528640" y="2104920"/>
            <a:ext cx="810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 rot="16200000">
            <a:off x="2185920" y="4608720"/>
            <a:ext cx="30096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 rot="16200000">
            <a:off x="2185920" y="3964320"/>
            <a:ext cx="30096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0.7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 rot="16200000">
            <a:off x="2185920" y="3316320"/>
            <a:ext cx="30096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 rot="16200000">
            <a:off x="2185920" y="2665440"/>
            <a:ext cx="30096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0.9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 rot="16200000">
            <a:off x="2185920" y="2017800"/>
            <a:ext cx="30096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2610000" y="1474920"/>
            <a:ext cx="4265640" cy="3743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4426920" y="1052640"/>
            <a:ext cx="48240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700" spc="-1" strike="noStrike">
                <a:solidFill>
                  <a:srgbClr val="000000"/>
                </a:solidFill>
                <a:latin typeface="Arial"/>
              </a:rPr>
              <a:t>Hare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>
            <a:off x="396720" y="333360"/>
            <a:ext cx="66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3b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>
            <a:off x="3713040" y="5877000"/>
            <a:ext cx="2149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600" spc="-1" strike="noStrike">
                <a:solidFill>
                  <a:srgbClr val="000000"/>
                </a:solidFill>
                <a:latin typeface="Arial"/>
              </a:rPr>
              <a:t>geographic distanc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1118880" y="3135240"/>
            <a:ext cx="100224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600" spc="-1" strike="noStrike">
                <a:solidFill>
                  <a:srgbClr val="000000"/>
                </a:solidFill>
                <a:latin typeface="Arial"/>
              </a:rPr>
              <a:t>genetic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600" spc="-1" strike="noStrike">
                <a:solidFill>
                  <a:srgbClr val="000000"/>
                </a:solidFill>
                <a:latin typeface="Arial"/>
              </a:rPr>
              <a:t>distanc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3" name=""/>
          <p:cNvSpPr/>
          <p:nvPr/>
        </p:nvSpPr>
        <p:spPr>
          <a:xfrm>
            <a:off x="2727360" y="3147840"/>
            <a:ext cx="982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2727360" y="292428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>
            <a:off x="2727360" y="329256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>
            <a:off x="2844720" y="3490920"/>
            <a:ext cx="9864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2844720" y="3390840"/>
            <a:ext cx="9864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>
            <a:off x="2844720" y="4040280"/>
            <a:ext cx="9864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6651720" y="1817640"/>
            <a:ext cx="9828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6651720" y="1852560"/>
            <a:ext cx="982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6651720" y="1844640"/>
            <a:ext cx="9828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>
            <a:off x="2727360" y="2932200"/>
            <a:ext cx="982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>
            <a:off x="2727360" y="3139920"/>
            <a:ext cx="9828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>
            <a:off x="2844720" y="3292560"/>
            <a:ext cx="9864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>
            <a:off x="2844720" y="3346560"/>
            <a:ext cx="9864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>
            <a:off x="2844720" y="4156200"/>
            <a:ext cx="98640" cy="997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120" bIns="24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>
            <a:off x="6651720" y="1763640"/>
            <a:ext cx="9828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>
            <a:off x="6651720" y="1744560"/>
            <a:ext cx="982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>
            <a:off x="6651720" y="186228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>
            <a:off x="2727360" y="2932200"/>
            <a:ext cx="982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>
            <a:off x="2844720" y="3608280"/>
            <a:ext cx="9864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>
            <a:off x="2844720" y="3292560"/>
            <a:ext cx="9864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>
            <a:off x="2844720" y="4156200"/>
            <a:ext cx="98640" cy="997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120" bIns="24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>
            <a:off x="6651720" y="1573200"/>
            <a:ext cx="982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"/>
          <p:cNvSpPr/>
          <p:nvPr/>
        </p:nvSpPr>
        <p:spPr>
          <a:xfrm>
            <a:off x="6642000" y="1682640"/>
            <a:ext cx="9864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>
            <a:off x="6651720" y="1771560"/>
            <a:ext cx="982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>
            <a:off x="2844720" y="3562200"/>
            <a:ext cx="9864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/>
          <p:nvPr/>
        </p:nvSpPr>
        <p:spPr>
          <a:xfrm>
            <a:off x="2844720" y="3544920"/>
            <a:ext cx="9864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>
            <a:off x="2844720" y="4192560"/>
            <a:ext cx="9864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/>
          <p:cNvSpPr/>
          <p:nvPr/>
        </p:nvSpPr>
        <p:spPr>
          <a:xfrm>
            <a:off x="6651720" y="2239920"/>
            <a:ext cx="9828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"/>
          <p:cNvSpPr/>
          <p:nvPr/>
        </p:nvSpPr>
        <p:spPr>
          <a:xfrm>
            <a:off x="6651720" y="1933560"/>
            <a:ext cx="982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>
            <a:off x="6651720" y="2050920"/>
            <a:ext cx="9828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>
            <a:off x="2727360" y="3716280"/>
            <a:ext cx="9828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>
            <a:off x="2727360" y="502920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"/>
          <p:cNvSpPr/>
          <p:nvPr/>
        </p:nvSpPr>
        <p:spPr>
          <a:xfrm>
            <a:off x="6678720" y="2176560"/>
            <a:ext cx="982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"/>
          <p:cNvSpPr/>
          <p:nvPr/>
        </p:nvSpPr>
        <p:spPr>
          <a:xfrm>
            <a:off x="6678720" y="1987560"/>
            <a:ext cx="982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"/>
          <p:cNvSpPr/>
          <p:nvPr/>
        </p:nvSpPr>
        <p:spPr>
          <a:xfrm>
            <a:off x="6678720" y="219564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>
            <a:off x="2727360" y="4336920"/>
            <a:ext cx="9828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>
            <a:off x="6678720" y="200664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"/>
          <p:cNvSpPr/>
          <p:nvPr/>
        </p:nvSpPr>
        <p:spPr>
          <a:xfrm>
            <a:off x="6678720" y="1987560"/>
            <a:ext cx="982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"/>
          <p:cNvSpPr/>
          <p:nvPr/>
        </p:nvSpPr>
        <p:spPr>
          <a:xfrm>
            <a:off x="6678720" y="2158920"/>
            <a:ext cx="9828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"/>
          <p:cNvSpPr/>
          <p:nvPr/>
        </p:nvSpPr>
        <p:spPr>
          <a:xfrm>
            <a:off x="6678720" y="297828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"/>
          <p:cNvSpPr/>
          <p:nvPr/>
        </p:nvSpPr>
        <p:spPr>
          <a:xfrm>
            <a:off x="6678720" y="2806560"/>
            <a:ext cx="9828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>
            <a:off x="6678720" y="2860560"/>
            <a:ext cx="9828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"/>
          <p:cNvSpPr/>
          <p:nvPr/>
        </p:nvSpPr>
        <p:spPr>
          <a:xfrm>
            <a:off x="2727360" y="305928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"/>
          <p:cNvSpPr/>
          <p:nvPr/>
        </p:nvSpPr>
        <p:spPr>
          <a:xfrm>
            <a:off x="2727360" y="318456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>
            <a:off x="2727360" y="4965840"/>
            <a:ext cx="98280" cy="997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120" bIns="24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>
            <a:off x="2771640" y="5218200"/>
            <a:ext cx="40593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>
            <a:off x="2771640" y="5218200"/>
            <a:ext cx="1800" cy="81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>
            <a:off x="3581280" y="5218200"/>
            <a:ext cx="1800" cy="81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"/>
          <p:cNvSpPr/>
          <p:nvPr/>
        </p:nvSpPr>
        <p:spPr>
          <a:xfrm>
            <a:off x="4392720" y="5218200"/>
            <a:ext cx="1440" cy="81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"/>
          <p:cNvSpPr/>
          <p:nvPr/>
        </p:nvSpPr>
        <p:spPr>
          <a:xfrm>
            <a:off x="5210280" y="5218200"/>
            <a:ext cx="1440" cy="81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"/>
          <p:cNvSpPr/>
          <p:nvPr/>
        </p:nvSpPr>
        <p:spPr>
          <a:xfrm>
            <a:off x="6021360" y="5218200"/>
            <a:ext cx="1440" cy="81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>
            <a:off x="6831000" y="5218200"/>
            <a:ext cx="1440" cy="81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>
            <a:off x="2664000" y="5345280"/>
            <a:ext cx="12096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"/>
          <p:cNvSpPr/>
          <p:nvPr/>
        </p:nvSpPr>
        <p:spPr>
          <a:xfrm>
            <a:off x="3298680" y="5345280"/>
            <a:ext cx="48240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2000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"/>
          <p:cNvSpPr/>
          <p:nvPr/>
        </p:nvSpPr>
        <p:spPr>
          <a:xfrm>
            <a:off x="4110120" y="5345280"/>
            <a:ext cx="48240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4000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"/>
          <p:cNvSpPr/>
          <p:nvPr/>
        </p:nvSpPr>
        <p:spPr>
          <a:xfrm>
            <a:off x="4927680" y="5345280"/>
            <a:ext cx="48240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6000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>
            <a:off x="5738760" y="5345280"/>
            <a:ext cx="48240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8000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>
            <a:off x="6490080" y="5345280"/>
            <a:ext cx="60264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10000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 flipV="1">
            <a:off x="2610000" y="1781280"/>
            <a:ext cx="1440" cy="3419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"/>
          <p:cNvSpPr/>
          <p:nvPr/>
        </p:nvSpPr>
        <p:spPr>
          <a:xfrm flipH="1">
            <a:off x="2528640" y="5200560"/>
            <a:ext cx="810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"/>
          <p:cNvSpPr/>
          <p:nvPr/>
        </p:nvSpPr>
        <p:spPr>
          <a:xfrm flipH="1">
            <a:off x="2528640" y="4516560"/>
            <a:ext cx="810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"/>
          <p:cNvSpPr/>
          <p:nvPr/>
        </p:nvSpPr>
        <p:spPr>
          <a:xfrm flipH="1">
            <a:off x="2528640" y="3832200"/>
            <a:ext cx="810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"/>
          <p:cNvSpPr/>
          <p:nvPr/>
        </p:nvSpPr>
        <p:spPr>
          <a:xfrm flipH="1">
            <a:off x="2528640" y="3147840"/>
            <a:ext cx="810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"/>
          <p:cNvSpPr/>
          <p:nvPr/>
        </p:nvSpPr>
        <p:spPr>
          <a:xfrm flipH="1">
            <a:off x="2528640" y="2465280"/>
            <a:ext cx="810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"/>
          <p:cNvSpPr/>
          <p:nvPr/>
        </p:nvSpPr>
        <p:spPr>
          <a:xfrm flipH="1">
            <a:off x="2528640" y="1781280"/>
            <a:ext cx="810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"/>
          <p:cNvSpPr/>
          <p:nvPr/>
        </p:nvSpPr>
        <p:spPr>
          <a:xfrm rot="16200000">
            <a:off x="2185920" y="4429440"/>
            <a:ext cx="30096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"/>
          <p:cNvSpPr/>
          <p:nvPr/>
        </p:nvSpPr>
        <p:spPr>
          <a:xfrm rot="16200000">
            <a:off x="2185920" y="3063960"/>
            <a:ext cx="30096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"/>
          <p:cNvSpPr/>
          <p:nvPr/>
        </p:nvSpPr>
        <p:spPr>
          <a:xfrm rot="16200000">
            <a:off x="2185920" y="1694160"/>
            <a:ext cx="30096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1.4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"/>
          <p:cNvSpPr/>
          <p:nvPr/>
        </p:nvSpPr>
        <p:spPr>
          <a:xfrm>
            <a:off x="2610000" y="1474920"/>
            <a:ext cx="4265640" cy="3743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"/>
          <p:cNvSpPr/>
          <p:nvPr/>
        </p:nvSpPr>
        <p:spPr>
          <a:xfrm>
            <a:off x="4426560" y="1052640"/>
            <a:ext cx="60264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700" spc="-1" strike="noStrike">
                <a:solidFill>
                  <a:srgbClr val="000000"/>
                </a:solidFill>
                <a:latin typeface="Arial"/>
              </a:rPr>
              <a:t>Ciona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"/>
          <p:cNvSpPr/>
          <p:nvPr/>
        </p:nvSpPr>
        <p:spPr>
          <a:xfrm>
            <a:off x="5961960" y="4862520"/>
            <a:ext cx="907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</a:t>
            </a:r>
            <a:r>
              <a:rPr b="0" lang="en-US" sz="18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=0.7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"/>
          <p:cNvSpPr/>
          <p:nvPr/>
        </p:nvSpPr>
        <p:spPr>
          <a:xfrm>
            <a:off x="397080" y="333360"/>
            <a:ext cx="650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3c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"/>
          <p:cNvSpPr/>
          <p:nvPr/>
        </p:nvSpPr>
        <p:spPr>
          <a:xfrm>
            <a:off x="3713040" y="5877000"/>
            <a:ext cx="2149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600" spc="-1" strike="noStrike">
                <a:solidFill>
                  <a:srgbClr val="000000"/>
                </a:solidFill>
                <a:latin typeface="Arial"/>
              </a:rPr>
              <a:t>geographic distanc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"/>
          <p:cNvSpPr/>
          <p:nvPr/>
        </p:nvSpPr>
        <p:spPr>
          <a:xfrm>
            <a:off x="1118880" y="3135240"/>
            <a:ext cx="100224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600" spc="-1" strike="noStrike">
                <a:solidFill>
                  <a:srgbClr val="000000"/>
                </a:solidFill>
                <a:latin typeface="Arial"/>
              </a:rPr>
              <a:t>genetic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600" spc="-1" strike="noStrike">
                <a:solidFill>
                  <a:srgbClr val="000000"/>
                </a:solidFill>
                <a:latin typeface="Arial"/>
              </a:rPr>
              <a:t>distanc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7" name=""/>
          <p:cNvSpPr/>
          <p:nvPr/>
        </p:nvSpPr>
        <p:spPr>
          <a:xfrm>
            <a:off x="5961960" y="4862520"/>
            <a:ext cx="907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</a:t>
            </a:r>
            <a:r>
              <a:rPr b="0" lang="en-US" sz="18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=0.0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"/>
          <p:cNvSpPr/>
          <p:nvPr/>
        </p:nvSpPr>
        <p:spPr>
          <a:xfrm>
            <a:off x="4554360" y="4273560"/>
            <a:ext cx="9864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"/>
          <p:cNvSpPr/>
          <p:nvPr/>
        </p:nvSpPr>
        <p:spPr>
          <a:xfrm>
            <a:off x="3897360" y="409428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"/>
          <p:cNvSpPr/>
          <p:nvPr/>
        </p:nvSpPr>
        <p:spPr>
          <a:xfrm>
            <a:off x="3897360" y="3751200"/>
            <a:ext cx="982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"/>
          <p:cNvSpPr/>
          <p:nvPr/>
        </p:nvSpPr>
        <p:spPr>
          <a:xfrm>
            <a:off x="3500280" y="3760920"/>
            <a:ext cx="1000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"/>
          <p:cNvSpPr/>
          <p:nvPr/>
        </p:nvSpPr>
        <p:spPr>
          <a:xfrm>
            <a:off x="6137280" y="4264200"/>
            <a:ext cx="100080" cy="997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120" bIns="24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"/>
          <p:cNvSpPr/>
          <p:nvPr/>
        </p:nvSpPr>
        <p:spPr>
          <a:xfrm>
            <a:off x="6137280" y="4408560"/>
            <a:ext cx="1000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"/>
          <p:cNvSpPr/>
          <p:nvPr/>
        </p:nvSpPr>
        <p:spPr>
          <a:xfrm>
            <a:off x="4022640" y="2770200"/>
            <a:ext cx="1000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"/>
          <p:cNvSpPr/>
          <p:nvPr/>
        </p:nvSpPr>
        <p:spPr>
          <a:xfrm>
            <a:off x="2871720" y="4210200"/>
            <a:ext cx="98640" cy="997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120" bIns="24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"/>
          <p:cNvSpPr/>
          <p:nvPr/>
        </p:nvSpPr>
        <p:spPr>
          <a:xfrm>
            <a:off x="3735360" y="4282920"/>
            <a:ext cx="9828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"/>
          <p:cNvSpPr/>
          <p:nvPr/>
        </p:nvSpPr>
        <p:spPr>
          <a:xfrm>
            <a:off x="3735360" y="4165560"/>
            <a:ext cx="9828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"/>
          <p:cNvSpPr/>
          <p:nvPr/>
        </p:nvSpPr>
        <p:spPr>
          <a:xfrm>
            <a:off x="5327640" y="3067200"/>
            <a:ext cx="100080" cy="997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120" bIns="24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"/>
          <p:cNvSpPr/>
          <p:nvPr/>
        </p:nvSpPr>
        <p:spPr>
          <a:xfrm>
            <a:off x="6264360" y="365292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"/>
          <p:cNvSpPr/>
          <p:nvPr/>
        </p:nvSpPr>
        <p:spPr>
          <a:xfrm>
            <a:off x="6264360" y="390528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"/>
          <p:cNvSpPr/>
          <p:nvPr/>
        </p:nvSpPr>
        <p:spPr>
          <a:xfrm>
            <a:off x="5102280" y="2023920"/>
            <a:ext cx="10008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"/>
          <p:cNvSpPr/>
          <p:nvPr/>
        </p:nvSpPr>
        <p:spPr>
          <a:xfrm>
            <a:off x="4562640" y="3760920"/>
            <a:ext cx="9972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"/>
          <p:cNvSpPr/>
          <p:nvPr/>
        </p:nvSpPr>
        <p:spPr>
          <a:xfrm>
            <a:off x="2727360" y="5019840"/>
            <a:ext cx="98280" cy="997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120" bIns="24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"/>
          <p:cNvSpPr/>
          <p:nvPr/>
        </p:nvSpPr>
        <p:spPr>
          <a:xfrm>
            <a:off x="4562640" y="2897280"/>
            <a:ext cx="9972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"/>
          <p:cNvSpPr/>
          <p:nvPr/>
        </p:nvSpPr>
        <p:spPr>
          <a:xfrm>
            <a:off x="6678720" y="346392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"/>
          <p:cNvSpPr/>
          <p:nvPr/>
        </p:nvSpPr>
        <p:spPr>
          <a:xfrm>
            <a:off x="6678720" y="3689280"/>
            <a:ext cx="9828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"/>
          <p:cNvSpPr/>
          <p:nvPr/>
        </p:nvSpPr>
        <p:spPr>
          <a:xfrm>
            <a:off x="4940280" y="1790640"/>
            <a:ext cx="10008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"/>
          <p:cNvSpPr/>
          <p:nvPr/>
        </p:nvSpPr>
        <p:spPr>
          <a:xfrm>
            <a:off x="3833640" y="3490920"/>
            <a:ext cx="1000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"/>
          <p:cNvSpPr/>
          <p:nvPr/>
        </p:nvSpPr>
        <p:spPr>
          <a:xfrm>
            <a:off x="4562640" y="2716200"/>
            <a:ext cx="9972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"/>
          <p:cNvSpPr/>
          <p:nvPr/>
        </p:nvSpPr>
        <p:spPr>
          <a:xfrm>
            <a:off x="6678720" y="3228840"/>
            <a:ext cx="982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"/>
          <p:cNvSpPr/>
          <p:nvPr/>
        </p:nvSpPr>
        <p:spPr>
          <a:xfrm>
            <a:off x="6678720" y="3535200"/>
            <a:ext cx="982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"/>
          <p:cNvSpPr/>
          <p:nvPr/>
        </p:nvSpPr>
        <p:spPr>
          <a:xfrm>
            <a:off x="4940280" y="1573200"/>
            <a:ext cx="1000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"/>
          <p:cNvSpPr/>
          <p:nvPr/>
        </p:nvSpPr>
        <p:spPr>
          <a:xfrm>
            <a:off x="3833640" y="3363840"/>
            <a:ext cx="1000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"/>
          <p:cNvSpPr/>
          <p:nvPr/>
        </p:nvSpPr>
        <p:spPr>
          <a:xfrm>
            <a:off x="6497640" y="3094200"/>
            <a:ext cx="100080" cy="997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120" bIns="24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"/>
          <p:cNvSpPr/>
          <p:nvPr/>
        </p:nvSpPr>
        <p:spPr>
          <a:xfrm>
            <a:off x="6488280" y="3336840"/>
            <a:ext cx="9972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"/>
          <p:cNvSpPr/>
          <p:nvPr/>
        </p:nvSpPr>
        <p:spPr>
          <a:xfrm>
            <a:off x="4275000" y="3832200"/>
            <a:ext cx="9864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"/>
          <p:cNvSpPr/>
          <p:nvPr/>
        </p:nvSpPr>
        <p:spPr>
          <a:xfrm>
            <a:off x="3483000" y="3174840"/>
            <a:ext cx="982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"/>
          <p:cNvSpPr/>
          <p:nvPr/>
        </p:nvSpPr>
        <p:spPr>
          <a:xfrm>
            <a:off x="2727360" y="502920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"/>
          <p:cNvSpPr/>
          <p:nvPr/>
        </p:nvSpPr>
        <p:spPr>
          <a:xfrm>
            <a:off x="4940280" y="2203560"/>
            <a:ext cx="1000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"/>
          <p:cNvSpPr/>
          <p:nvPr/>
        </p:nvSpPr>
        <p:spPr>
          <a:xfrm>
            <a:off x="6281640" y="3706920"/>
            <a:ext cx="9864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"/>
          <p:cNvSpPr/>
          <p:nvPr/>
        </p:nvSpPr>
        <p:spPr>
          <a:xfrm>
            <a:off x="4932360" y="262728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"/>
          <p:cNvSpPr/>
          <p:nvPr/>
        </p:nvSpPr>
        <p:spPr>
          <a:xfrm>
            <a:off x="6281640" y="3959280"/>
            <a:ext cx="9864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"/>
          <p:cNvSpPr/>
          <p:nvPr/>
        </p:nvSpPr>
        <p:spPr>
          <a:xfrm>
            <a:off x="4176720" y="2338560"/>
            <a:ext cx="98280" cy="997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120" bIns="24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"/>
          <p:cNvSpPr/>
          <p:nvPr/>
        </p:nvSpPr>
        <p:spPr>
          <a:xfrm>
            <a:off x="2771640" y="5218200"/>
            <a:ext cx="41040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"/>
          <p:cNvSpPr/>
          <p:nvPr/>
        </p:nvSpPr>
        <p:spPr>
          <a:xfrm>
            <a:off x="2771640" y="5218200"/>
            <a:ext cx="1800" cy="81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"/>
          <p:cNvSpPr/>
          <p:nvPr/>
        </p:nvSpPr>
        <p:spPr>
          <a:xfrm>
            <a:off x="3456000" y="5218200"/>
            <a:ext cx="1440" cy="81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"/>
          <p:cNvSpPr/>
          <p:nvPr/>
        </p:nvSpPr>
        <p:spPr>
          <a:xfrm>
            <a:off x="4140360" y="5218200"/>
            <a:ext cx="1440" cy="81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"/>
          <p:cNvSpPr/>
          <p:nvPr/>
        </p:nvSpPr>
        <p:spPr>
          <a:xfrm>
            <a:off x="4824360" y="5218200"/>
            <a:ext cx="1800" cy="81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"/>
          <p:cNvSpPr/>
          <p:nvPr/>
        </p:nvSpPr>
        <p:spPr>
          <a:xfrm>
            <a:off x="5508720" y="5218200"/>
            <a:ext cx="1440" cy="81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"/>
          <p:cNvSpPr/>
          <p:nvPr/>
        </p:nvSpPr>
        <p:spPr>
          <a:xfrm>
            <a:off x="6191280" y="5218200"/>
            <a:ext cx="1440" cy="81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"/>
          <p:cNvSpPr/>
          <p:nvPr/>
        </p:nvSpPr>
        <p:spPr>
          <a:xfrm>
            <a:off x="6875640" y="5218200"/>
            <a:ext cx="1440" cy="81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"/>
          <p:cNvSpPr/>
          <p:nvPr/>
        </p:nvSpPr>
        <p:spPr>
          <a:xfrm>
            <a:off x="2664000" y="5345280"/>
            <a:ext cx="12096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"/>
          <p:cNvSpPr/>
          <p:nvPr/>
        </p:nvSpPr>
        <p:spPr>
          <a:xfrm>
            <a:off x="3232080" y="5345280"/>
            <a:ext cx="36180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"/>
          <p:cNvSpPr/>
          <p:nvPr/>
        </p:nvSpPr>
        <p:spPr>
          <a:xfrm>
            <a:off x="3916440" y="5345280"/>
            <a:ext cx="36180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200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"/>
          <p:cNvSpPr/>
          <p:nvPr/>
        </p:nvSpPr>
        <p:spPr>
          <a:xfrm>
            <a:off x="4600440" y="5345280"/>
            <a:ext cx="36180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300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"/>
          <p:cNvSpPr/>
          <p:nvPr/>
        </p:nvSpPr>
        <p:spPr>
          <a:xfrm>
            <a:off x="5284800" y="5345280"/>
            <a:ext cx="36180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400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"/>
          <p:cNvSpPr/>
          <p:nvPr/>
        </p:nvSpPr>
        <p:spPr>
          <a:xfrm>
            <a:off x="5967360" y="5345280"/>
            <a:ext cx="36180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500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"/>
          <p:cNvSpPr/>
          <p:nvPr/>
        </p:nvSpPr>
        <p:spPr>
          <a:xfrm>
            <a:off x="6651720" y="5345280"/>
            <a:ext cx="36180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600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"/>
          <p:cNvSpPr/>
          <p:nvPr/>
        </p:nvSpPr>
        <p:spPr>
          <a:xfrm flipV="1">
            <a:off x="2610000" y="2114640"/>
            <a:ext cx="1440" cy="2627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"/>
          <p:cNvSpPr/>
          <p:nvPr/>
        </p:nvSpPr>
        <p:spPr>
          <a:xfrm flipH="1">
            <a:off x="2528640" y="4741920"/>
            <a:ext cx="810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"/>
          <p:cNvSpPr/>
          <p:nvPr/>
        </p:nvSpPr>
        <p:spPr>
          <a:xfrm flipH="1">
            <a:off x="2528640" y="4084560"/>
            <a:ext cx="810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"/>
          <p:cNvSpPr/>
          <p:nvPr/>
        </p:nvSpPr>
        <p:spPr>
          <a:xfrm flipH="1">
            <a:off x="2528640" y="3427560"/>
            <a:ext cx="810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"/>
          <p:cNvSpPr/>
          <p:nvPr/>
        </p:nvSpPr>
        <p:spPr>
          <a:xfrm flipH="1">
            <a:off x="2528640" y="2770200"/>
            <a:ext cx="810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"/>
          <p:cNvSpPr/>
          <p:nvPr/>
        </p:nvSpPr>
        <p:spPr>
          <a:xfrm flipH="1">
            <a:off x="2528640" y="2114640"/>
            <a:ext cx="810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"/>
          <p:cNvSpPr/>
          <p:nvPr/>
        </p:nvSpPr>
        <p:spPr>
          <a:xfrm rot="16200000">
            <a:off x="2185920" y="4654800"/>
            <a:ext cx="30096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"/>
          <p:cNvSpPr/>
          <p:nvPr/>
        </p:nvSpPr>
        <p:spPr>
          <a:xfrm rot="16200000">
            <a:off x="2185920" y="3343320"/>
            <a:ext cx="30096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2.0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"/>
          <p:cNvSpPr/>
          <p:nvPr/>
        </p:nvSpPr>
        <p:spPr>
          <a:xfrm rot="16200000">
            <a:off x="2185920" y="2027520"/>
            <a:ext cx="30096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3.0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"/>
          <p:cNvSpPr/>
          <p:nvPr/>
        </p:nvSpPr>
        <p:spPr>
          <a:xfrm>
            <a:off x="2610000" y="1474920"/>
            <a:ext cx="4265640" cy="3743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"/>
          <p:cNvSpPr/>
          <p:nvPr/>
        </p:nvSpPr>
        <p:spPr>
          <a:xfrm>
            <a:off x="4356000" y="1052640"/>
            <a:ext cx="78084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700" spc="-1" strike="noStrike">
                <a:solidFill>
                  <a:srgbClr val="000000"/>
                </a:solidFill>
                <a:latin typeface="Arial"/>
              </a:rPr>
              <a:t>Termite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"/>
          <p:cNvSpPr/>
          <p:nvPr/>
        </p:nvSpPr>
        <p:spPr>
          <a:xfrm>
            <a:off x="396720" y="333360"/>
            <a:ext cx="66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3d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"/>
          <p:cNvSpPr/>
          <p:nvPr/>
        </p:nvSpPr>
        <p:spPr>
          <a:xfrm>
            <a:off x="3713040" y="5877000"/>
            <a:ext cx="2149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600" spc="-1" strike="noStrike">
                <a:solidFill>
                  <a:srgbClr val="000000"/>
                </a:solidFill>
                <a:latin typeface="Arial"/>
              </a:rPr>
              <a:t>geographic distanc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"/>
          <p:cNvSpPr/>
          <p:nvPr/>
        </p:nvSpPr>
        <p:spPr>
          <a:xfrm>
            <a:off x="1118880" y="3135240"/>
            <a:ext cx="100224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600" spc="-1" strike="noStrike">
                <a:solidFill>
                  <a:srgbClr val="000000"/>
                </a:solidFill>
                <a:latin typeface="Arial"/>
              </a:rPr>
              <a:t>genetic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600" spc="-1" strike="noStrike">
                <a:solidFill>
                  <a:srgbClr val="000000"/>
                </a:solidFill>
                <a:latin typeface="Arial"/>
              </a:rPr>
              <a:t>distanc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3" name=""/>
          <p:cNvSpPr/>
          <p:nvPr/>
        </p:nvSpPr>
        <p:spPr>
          <a:xfrm>
            <a:off x="5961960" y="4862520"/>
            <a:ext cx="907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</a:t>
            </a:r>
            <a:r>
              <a:rPr b="0" lang="en-US" sz="18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=0.2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"/>
          <p:cNvSpPr/>
          <p:nvPr/>
        </p:nvSpPr>
        <p:spPr>
          <a:xfrm>
            <a:off x="2727360" y="3336840"/>
            <a:ext cx="982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"/>
          <p:cNvSpPr/>
          <p:nvPr/>
        </p:nvSpPr>
        <p:spPr>
          <a:xfrm>
            <a:off x="2727360" y="4479840"/>
            <a:ext cx="982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"/>
          <p:cNvSpPr/>
          <p:nvPr/>
        </p:nvSpPr>
        <p:spPr>
          <a:xfrm>
            <a:off x="6102360" y="292428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"/>
          <p:cNvSpPr/>
          <p:nvPr/>
        </p:nvSpPr>
        <p:spPr>
          <a:xfrm>
            <a:off x="6102360" y="3697200"/>
            <a:ext cx="982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"/>
          <p:cNvSpPr/>
          <p:nvPr/>
        </p:nvSpPr>
        <p:spPr>
          <a:xfrm>
            <a:off x="6102360" y="1844640"/>
            <a:ext cx="9828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"/>
          <p:cNvSpPr/>
          <p:nvPr/>
        </p:nvSpPr>
        <p:spPr>
          <a:xfrm>
            <a:off x="4527720" y="3373560"/>
            <a:ext cx="98280" cy="997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120" bIns="24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"/>
          <p:cNvSpPr/>
          <p:nvPr/>
        </p:nvSpPr>
        <p:spPr>
          <a:xfrm>
            <a:off x="4527720" y="4813200"/>
            <a:ext cx="9828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"/>
          <p:cNvSpPr/>
          <p:nvPr/>
        </p:nvSpPr>
        <p:spPr>
          <a:xfrm>
            <a:off x="4527720" y="3022560"/>
            <a:ext cx="9828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"/>
          <p:cNvSpPr/>
          <p:nvPr/>
        </p:nvSpPr>
        <p:spPr>
          <a:xfrm>
            <a:off x="4527720" y="3363840"/>
            <a:ext cx="982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"/>
          <p:cNvSpPr/>
          <p:nvPr/>
        </p:nvSpPr>
        <p:spPr>
          <a:xfrm>
            <a:off x="2727360" y="313056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"/>
          <p:cNvSpPr/>
          <p:nvPr/>
        </p:nvSpPr>
        <p:spPr>
          <a:xfrm>
            <a:off x="6102360" y="378792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"/>
          <p:cNvSpPr/>
          <p:nvPr/>
        </p:nvSpPr>
        <p:spPr>
          <a:xfrm>
            <a:off x="6102360" y="3562200"/>
            <a:ext cx="982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"/>
          <p:cNvSpPr/>
          <p:nvPr/>
        </p:nvSpPr>
        <p:spPr>
          <a:xfrm>
            <a:off x="6102360" y="229392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"/>
          <p:cNvSpPr/>
          <p:nvPr/>
        </p:nvSpPr>
        <p:spPr>
          <a:xfrm>
            <a:off x="4527720" y="3581280"/>
            <a:ext cx="9828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"/>
          <p:cNvSpPr/>
          <p:nvPr/>
        </p:nvSpPr>
        <p:spPr>
          <a:xfrm>
            <a:off x="4527720" y="3309840"/>
            <a:ext cx="982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"/>
          <p:cNvSpPr/>
          <p:nvPr/>
        </p:nvSpPr>
        <p:spPr>
          <a:xfrm>
            <a:off x="4527720" y="2932200"/>
            <a:ext cx="982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"/>
          <p:cNvSpPr/>
          <p:nvPr/>
        </p:nvSpPr>
        <p:spPr>
          <a:xfrm>
            <a:off x="4527720" y="351792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"/>
          <p:cNvSpPr/>
          <p:nvPr/>
        </p:nvSpPr>
        <p:spPr>
          <a:xfrm>
            <a:off x="6102360" y="3481560"/>
            <a:ext cx="98280" cy="997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120" bIns="24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"/>
          <p:cNvSpPr/>
          <p:nvPr/>
        </p:nvSpPr>
        <p:spPr>
          <a:xfrm>
            <a:off x="6102360" y="4641840"/>
            <a:ext cx="982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"/>
          <p:cNvSpPr/>
          <p:nvPr/>
        </p:nvSpPr>
        <p:spPr>
          <a:xfrm>
            <a:off x="6102360" y="2365200"/>
            <a:ext cx="982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"/>
          <p:cNvSpPr/>
          <p:nvPr/>
        </p:nvSpPr>
        <p:spPr>
          <a:xfrm>
            <a:off x="4527720" y="406728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"/>
          <p:cNvSpPr/>
          <p:nvPr/>
        </p:nvSpPr>
        <p:spPr>
          <a:xfrm>
            <a:off x="4527720" y="3716280"/>
            <a:ext cx="9828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"/>
          <p:cNvSpPr/>
          <p:nvPr/>
        </p:nvSpPr>
        <p:spPr>
          <a:xfrm>
            <a:off x="4527720" y="318456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"/>
          <p:cNvSpPr/>
          <p:nvPr/>
        </p:nvSpPr>
        <p:spPr>
          <a:xfrm>
            <a:off x="4527720" y="3635280"/>
            <a:ext cx="9828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"/>
          <p:cNvSpPr/>
          <p:nvPr/>
        </p:nvSpPr>
        <p:spPr>
          <a:xfrm>
            <a:off x="2727360" y="424656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"/>
          <p:cNvSpPr/>
          <p:nvPr/>
        </p:nvSpPr>
        <p:spPr>
          <a:xfrm>
            <a:off x="2727360" y="3940200"/>
            <a:ext cx="982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"/>
          <p:cNvSpPr/>
          <p:nvPr/>
        </p:nvSpPr>
        <p:spPr>
          <a:xfrm>
            <a:off x="6669000" y="3481560"/>
            <a:ext cx="98640" cy="997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120" bIns="24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"/>
          <p:cNvSpPr/>
          <p:nvPr/>
        </p:nvSpPr>
        <p:spPr>
          <a:xfrm>
            <a:off x="6669000" y="3508200"/>
            <a:ext cx="9864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"/>
          <p:cNvSpPr/>
          <p:nvPr/>
        </p:nvSpPr>
        <p:spPr>
          <a:xfrm>
            <a:off x="6669000" y="3417840"/>
            <a:ext cx="9864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"/>
          <p:cNvSpPr/>
          <p:nvPr/>
        </p:nvSpPr>
        <p:spPr>
          <a:xfrm>
            <a:off x="6669000" y="2851200"/>
            <a:ext cx="9864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"/>
          <p:cNvSpPr/>
          <p:nvPr/>
        </p:nvSpPr>
        <p:spPr>
          <a:xfrm>
            <a:off x="2727360" y="4398840"/>
            <a:ext cx="982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"/>
          <p:cNvSpPr/>
          <p:nvPr/>
        </p:nvSpPr>
        <p:spPr>
          <a:xfrm>
            <a:off x="6669000" y="3544920"/>
            <a:ext cx="9864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"/>
          <p:cNvSpPr/>
          <p:nvPr/>
        </p:nvSpPr>
        <p:spPr>
          <a:xfrm>
            <a:off x="6669000" y="4452840"/>
            <a:ext cx="9864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"/>
          <p:cNvSpPr/>
          <p:nvPr/>
        </p:nvSpPr>
        <p:spPr>
          <a:xfrm>
            <a:off x="6669000" y="3608280"/>
            <a:ext cx="9864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"/>
          <p:cNvSpPr/>
          <p:nvPr/>
        </p:nvSpPr>
        <p:spPr>
          <a:xfrm>
            <a:off x="6678720" y="200664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"/>
          <p:cNvSpPr/>
          <p:nvPr/>
        </p:nvSpPr>
        <p:spPr>
          <a:xfrm>
            <a:off x="6678720" y="284328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"/>
          <p:cNvSpPr/>
          <p:nvPr/>
        </p:nvSpPr>
        <p:spPr>
          <a:xfrm>
            <a:off x="6678720" y="230364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"/>
          <p:cNvSpPr/>
          <p:nvPr/>
        </p:nvSpPr>
        <p:spPr>
          <a:xfrm>
            <a:off x="6678720" y="197964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"/>
          <p:cNvSpPr/>
          <p:nvPr/>
        </p:nvSpPr>
        <p:spPr>
          <a:xfrm>
            <a:off x="6678720" y="1573200"/>
            <a:ext cx="982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"/>
          <p:cNvSpPr/>
          <p:nvPr/>
        </p:nvSpPr>
        <p:spPr>
          <a:xfrm>
            <a:off x="2727360" y="390528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"/>
          <p:cNvSpPr/>
          <p:nvPr/>
        </p:nvSpPr>
        <p:spPr>
          <a:xfrm>
            <a:off x="2727360" y="502920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"/>
          <p:cNvSpPr/>
          <p:nvPr/>
        </p:nvSpPr>
        <p:spPr>
          <a:xfrm>
            <a:off x="2727360" y="4003560"/>
            <a:ext cx="98280" cy="98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"/>
          <p:cNvSpPr/>
          <p:nvPr/>
        </p:nvSpPr>
        <p:spPr>
          <a:xfrm>
            <a:off x="2727360" y="3994200"/>
            <a:ext cx="982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"/>
          <p:cNvSpPr/>
          <p:nvPr/>
        </p:nvSpPr>
        <p:spPr>
          <a:xfrm>
            <a:off x="2727360" y="3878280"/>
            <a:ext cx="98280" cy="98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2680" bIns="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"/>
          <p:cNvSpPr/>
          <p:nvPr/>
        </p:nvSpPr>
        <p:spPr>
          <a:xfrm>
            <a:off x="2727360" y="3336840"/>
            <a:ext cx="98280" cy="100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"/>
          <p:cNvSpPr/>
          <p:nvPr/>
        </p:nvSpPr>
        <p:spPr>
          <a:xfrm>
            <a:off x="2771640" y="5218200"/>
            <a:ext cx="38433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"/>
          <p:cNvSpPr/>
          <p:nvPr/>
        </p:nvSpPr>
        <p:spPr>
          <a:xfrm>
            <a:off x="2771640" y="5218200"/>
            <a:ext cx="1800" cy="81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"/>
          <p:cNvSpPr/>
          <p:nvPr/>
        </p:nvSpPr>
        <p:spPr>
          <a:xfrm>
            <a:off x="4049640" y="5218200"/>
            <a:ext cx="1800" cy="81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"/>
          <p:cNvSpPr/>
          <p:nvPr/>
        </p:nvSpPr>
        <p:spPr>
          <a:xfrm>
            <a:off x="5337000" y="5218200"/>
            <a:ext cx="1800" cy="81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"/>
          <p:cNvSpPr/>
          <p:nvPr/>
        </p:nvSpPr>
        <p:spPr>
          <a:xfrm>
            <a:off x="6615000" y="5218200"/>
            <a:ext cx="1800" cy="81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"/>
          <p:cNvSpPr/>
          <p:nvPr/>
        </p:nvSpPr>
        <p:spPr>
          <a:xfrm>
            <a:off x="2664000" y="5345280"/>
            <a:ext cx="12096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"/>
          <p:cNvSpPr/>
          <p:nvPr/>
        </p:nvSpPr>
        <p:spPr>
          <a:xfrm>
            <a:off x="3825720" y="5345280"/>
            <a:ext cx="36180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500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"/>
          <p:cNvSpPr/>
          <p:nvPr/>
        </p:nvSpPr>
        <p:spPr>
          <a:xfrm>
            <a:off x="5054760" y="5345280"/>
            <a:ext cx="48240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1000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"/>
          <p:cNvSpPr/>
          <p:nvPr/>
        </p:nvSpPr>
        <p:spPr>
          <a:xfrm>
            <a:off x="6332400" y="5345280"/>
            <a:ext cx="48240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1500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"/>
          <p:cNvSpPr/>
          <p:nvPr/>
        </p:nvSpPr>
        <p:spPr>
          <a:xfrm flipV="1">
            <a:off x="2610000" y="1627200"/>
            <a:ext cx="1440" cy="3060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"/>
          <p:cNvSpPr/>
          <p:nvPr/>
        </p:nvSpPr>
        <p:spPr>
          <a:xfrm flipH="1">
            <a:off x="2528640" y="4687920"/>
            <a:ext cx="810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"/>
          <p:cNvSpPr/>
          <p:nvPr/>
        </p:nvSpPr>
        <p:spPr>
          <a:xfrm flipH="1">
            <a:off x="2528640" y="3922560"/>
            <a:ext cx="810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"/>
          <p:cNvSpPr/>
          <p:nvPr/>
        </p:nvSpPr>
        <p:spPr>
          <a:xfrm flipH="1">
            <a:off x="2528640" y="3157560"/>
            <a:ext cx="810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"/>
          <p:cNvSpPr/>
          <p:nvPr/>
        </p:nvSpPr>
        <p:spPr>
          <a:xfrm flipH="1">
            <a:off x="2528640" y="2392200"/>
            <a:ext cx="810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"/>
          <p:cNvSpPr/>
          <p:nvPr/>
        </p:nvSpPr>
        <p:spPr>
          <a:xfrm flipH="1">
            <a:off x="2528640" y="1627200"/>
            <a:ext cx="810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"/>
          <p:cNvSpPr/>
          <p:nvPr/>
        </p:nvSpPr>
        <p:spPr>
          <a:xfrm rot="16200000">
            <a:off x="2185920" y="4600800"/>
            <a:ext cx="30096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"/>
          <p:cNvSpPr/>
          <p:nvPr/>
        </p:nvSpPr>
        <p:spPr>
          <a:xfrm rot="16200000">
            <a:off x="2185920" y="3073680"/>
            <a:ext cx="30096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"/>
          <p:cNvSpPr/>
          <p:nvPr/>
        </p:nvSpPr>
        <p:spPr>
          <a:xfrm rot="16200000">
            <a:off x="2185920" y="1540080"/>
            <a:ext cx="30096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1.2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"/>
          <p:cNvSpPr/>
          <p:nvPr/>
        </p:nvSpPr>
        <p:spPr>
          <a:xfrm>
            <a:off x="2610000" y="1474920"/>
            <a:ext cx="4265640" cy="3743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"/>
          <p:cNvSpPr/>
          <p:nvPr/>
        </p:nvSpPr>
        <p:spPr>
          <a:xfrm>
            <a:off x="4428000" y="1052640"/>
            <a:ext cx="68508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700" spc="-1" strike="noStrike">
                <a:solidFill>
                  <a:srgbClr val="000000"/>
                </a:solidFill>
                <a:latin typeface="Arial"/>
              </a:rPr>
              <a:t>Oyster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"/>
          <p:cNvSpPr/>
          <p:nvPr/>
        </p:nvSpPr>
        <p:spPr>
          <a:xfrm>
            <a:off x="397080" y="333360"/>
            <a:ext cx="650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3e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"/>
          <p:cNvSpPr/>
          <p:nvPr/>
        </p:nvSpPr>
        <p:spPr>
          <a:xfrm>
            <a:off x="3713040" y="5877000"/>
            <a:ext cx="2149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600" spc="-1" strike="noStrike">
                <a:solidFill>
                  <a:srgbClr val="000000"/>
                </a:solidFill>
                <a:latin typeface="Arial"/>
              </a:rPr>
              <a:t>geographic distanc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"/>
          <p:cNvSpPr/>
          <p:nvPr/>
        </p:nvSpPr>
        <p:spPr>
          <a:xfrm>
            <a:off x="1118880" y="3135240"/>
            <a:ext cx="100224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600" spc="-1" strike="noStrike">
                <a:solidFill>
                  <a:srgbClr val="000000"/>
                </a:solidFill>
                <a:latin typeface="Arial"/>
              </a:rPr>
              <a:t>genetic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600" spc="-1" strike="noStrike">
                <a:solidFill>
                  <a:srgbClr val="000000"/>
                </a:solidFill>
                <a:latin typeface="Arial"/>
              </a:rPr>
              <a:t>distanc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60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7-26T15:17:04Z</dcterms:created>
  <dc:creator>GALTIER</dc:creator>
  <dc:description/>
  <dc:language>en-US</dc:language>
  <cp:lastModifiedBy>GALTIER</cp:lastModifiedBy>
  <dcterms:modified xsi:type="dcterms:W3CDTF">2013-02-22T09:43:59Z</dcterms:modified>
  <cp:revision>108</cp:revision>
  <dc:subject/>
  <dc:title>Diapositive 1</dc:title>
</cp:coreProperties>
</file>